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62" r:id="rId2"/>
    <p:sldId id="263" r:id="rId3"/>
    <p:sldId id="264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3"/>
    <p:restoredTop sz="90000"/>
  </p:normalViewPr>
  <p:slideViewPr>
    <p:cSldViewPr snapToGrid="0">
      <p:cViewPr varScale="1">
        <p:scale>
          <a:sx n="114" d="100"/>
          <a:sy n="114" d="100"/>
        </p:scale>
        <p:origin x="48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F192FCE-B044-CF44-95A0-88356D011018}" type="datetimeFigureOut">
              <a:rPr lang="en-US" smtClean="0"/>
              <a:t>7/8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C6859C5-A2A2-E04F-B345-387DB2A39B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57539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C0F2052-97BF-B24E-A719-4467A9121F7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08480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C0F2052-97BF-B24E-A719-4467A9121F7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50442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C3D1A7-8B33-2A9C-3D79-2D8CA5585BA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80A1BEC-8D42-DD58-6B21-FE5BE5ED825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B85B64-13E5-FC73-8CE0-BA6B2F94E9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446F76-F51B-C761-AF57-8EF31A675C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14D741-6FF7-90E7-F768-280CAF9464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8962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5A75FA-CAEE-D75A-BAAF-C6E65F2E64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EF4055B-2F6F-E0FA-B1D0-AF81383308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D9E1F5-914C-8ED7-95DF-0D6C08C233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726D88-1D03-9BC3-D248-A4659EAFEA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E8B359-425E-8152-42CC-632AEA9CC2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62135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56B629E-9F22-C809-283A-451EB6B08C8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F71975D-2D40-AEDE-E2DC-EB92B587A8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C72ACC-0A8C-EF01-4186-D639257BAA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8A1C44-20FB-4703-6858-1941698F7B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445E9C-CCDF-9903-0F5E-B14C94A54C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4666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7F5990-0107-A0FF-5367-4DFCB9932E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53629E-8FF8-05C4-EFFF-AF147232541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A36B90-F159-0FD5-278A-5330BFC23C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572EB7-23A4-7020-28B7-9DE84BC789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8C029A-D067-C1A4-1D75-9520A2E005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6224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8533D7-06AD-F6BC-D2FE-F58AFB06A1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F3A8E7-2665-288A-658B-6D5DB1B5FD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80571B-D2A2-BB9E-A670-2145182FC3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EBE870-8E3D-F72F-5132-37A71BF486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BCA445-7F5D-FE0F-B171-02D3549300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85308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7A843D-F6D6-C6BD-09F6-263E6B7C01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A3ACCE-5729-5321-370E-CFB1965225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99CCFD7-B5D5-1DBC-2E21-B3954D476E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83EB108-18E1-95F1-4294-D480CEA018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207551-D9C7-09AB-50C8-C2201EF6B0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5E6AAD4-5F7C-531A-97AA-6B21A31E23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61467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55B0AD-D30D-AB8C-C998-7868DC5E1B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A7D5E1-BC31-1841-B4B5-2EA6A90648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4856AA5-0303-674F-8394-9B3CFCF3B7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43D93B5-220C-0E80-C13B-990A66DE6BD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37D25F5-3CB0-1FC2-0F48-947AC62E2E0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18DEEC5-0475-C38A-EDF6-0FBE5852E4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91A1346-A7F2-65C5-7012-15457D8A5A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EF87335-A646-B213-1C10-1C98A9B953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7616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236D62-2F92-7C47-A682-5DD3FF09AA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3F44F52-DDB7-9A97-2CD7-7AEA8B0EA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69C29F9-C396-0EF2-A613-986A87365D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756CFD-3016-E9A2-6674-4E5ABD61F3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6077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D064A98-4F84-0EF5-438E-6011F989B7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E688B85-CE20-15C9-888C-C03130E7E0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B4A0964-1865-AA71-D53A-F5559FE529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54841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E3EAC3-70B2-795F-A5B5-F019BB298C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CC90194-456A-1377-364B-6B87C73EB2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6C0F954-9B7B-9A5B-3CEF-005AD1635C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D27A72-B049-163B-4636-0C93895D02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B3A693-39DC-485F-899E-4125022EE0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BEF0EA4-C4AE-BF39-E913-50F53C1F80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3333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FFDB27-F929-705B-193B-085DF717FF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F34819E-0C79-2193-75A4-BE774C34957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4107EB6-73C7-8B94-7F00-B69071606A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7E8051-FA1E-FC29-8974-E3EBDFB5C9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1DBF45-353E-B306-1AD0-95D4A4E17D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A4AB019-9AAD-5DB4-CE51-D5E0BBB21A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94529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21A9CC2-5697-6C98-BA4E-D15CFBEA03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5FBF7C-91BA-9E64-8C01-5C7B4D621F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1081D5-4F36-F5A5-2310-69C2684B75D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2050F4-33D5-CE82-FD97-3FA0EBBAA94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954360-1CEE-ADBB-F6F0-B9E3C0941F3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44116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C6E1940E-7A0C-CFFB-3BA5-64134E5DBF36}"/>
              </a:ext>
            </a:extLst>
          </p:cNvPr>
          <p:cNvSpPr/>
          <p:nvPr/>
        </p:nvSpPr>
        <p:spPr>
          <a:xfrm>
            <a:off x="269557" y="188913"/>
            <a:ext cx="381607" cy="35141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787DA0ED-F7C9-877D-2514-322D2C3E370A}"/>
              </a:ext>
            </a:extLst>
          </p:cNvPr>
          <p:cNvSpPr/>
          <p:nvPr/>
        </p:nvSpPr>
        <p:spPr>
          <a:xfrm>
            <a:off x="6420975" y="188913"/>
            <a:ext cx="381607" cy="35141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DB37337-F041-B31D-3F50-589A274C83B4}"/>
              </a:ext>
            </a:extLst>
          </p:cNvPr>
          <p:cNvSpPr txBox="1"/>
          <p:nvPr/>
        </p:nvSpPr>
        <p:spPr>
          <a:xfrm>
            <a:off x="771525" y="15868"/>
            <a:ext cx="4857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C2606B5-FB4E-AA11-1C30-B3DE626F9E48}"/>
              </a:ext>
            </a:extLst>
          </p:cNvPr>
          <p:cNvSpPr txBox="1"/>
          <p:nvPr/>
        </p:nvSpPr>
        <p:spPr>
          <a:xfrm>
            <a:off x="6271780" y="0"/>
            <a:ext cx="4857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4D6C73AA-5E31-4C7F-085B-61EB432D94E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175" y="268287"/>
            <a:ext cx="6400800" cy="64008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27119A27-B569-173C-F332-F6CAF9F7D4C7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4587"/>
          <a:stretch>
            <a:fillRect/>
          </a:stretch>
        </p:blipFill>
        <p:spPr>
          <a:xfrm>
            <a:off x="6095999" y="268287"/>
            <a:ext cx="6107213" cy="640080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C4050EF6-284A-7256-80F8-D72233C13A77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523" t="5105" r="95201"/>
          <a:stretch>
            <a:fillRect/>
          </a:stretch>
        </p:blipFill>
        <p:spPr>
          <a:xfrm>
            <a:off x="5822309" y="540327"/>
            <a:ext cx="273690" cy="607405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049A45A-A85E-4F4D-F68D-7356C28BBDF8}"/>
              </a:ext>
            </a:extLst>
          </p:cNvPr>
          <p:cNvSpPr txBox="1"/>
          <p:nvPr/>
        </p:nvSpPr>
        <p:spPr>
          <a:xfrm>
            <a:off x="9617328" y="-4294"/>
            <a:ext cx="258588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l Figure 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334719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5C544ECC-B180-A4F7-9FEF-A181C0777688}"/>
              </a:ext>
            </a:extLst>
          </p:cNvPr>
          <p:cNvSpPr/>
          <p:nvPr/>
        </p:nvSpPr>
        <p:spPr>
          <a:xfrm>
            <a:off x="523262" y="264318"/>
            <a:ext cx="381607" cy="35141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81E40E88-227B-2799-2C16-2370A2A4BE1D}"/>
              </a:ext>
            </a:extLst>
          </p:cNvPr>
          <p:cNvSpPr/>
          <p:nvPr/>
        </p:nvSpPr>
        <p:spPr>
          <a:xfrm>
            <a:off x="6504103" y="196127"/>
            <a:ext cx="381607" cy="35141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61931FE-CDA5-E27F-081E-5CBA81B4E061}"/>
              </a:ext>
            </a:extLst>
          </p:cNvPr>
          <p:cNvSpPr txBox="1"/>
          <p:nvPr/>
        </p:nvSpPr>
        <p:spPr>
          <a:xfrm>
            <a:off x="771525" y="15868"/>
            <a:ext cx="4857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44BE0A9-A765-D6D6-D78A-936932267830}"/>
              </a:ext>
            </a:extLst>
          </p:cNvPr>
          <p:cNvSpPr txBox="1"/>
          <p:nvPr/>
        </p:nvSpPr>
        <p:spPr>
          <a:xfrm>
            <a:off x="6271780" y="0"/>
            <a:ext cx="4857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16544E0E-EA0B-6261-67E0-75051459CD51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4355"/>
          <a:stretch>
            <a:fillRect/>
          </a:stretch>
        </p:blipFill>
        <p:spPr>
          <a:xfrm>
            <a:off x="278780" y="316825"/>
            <a:ext cx="6122020" cy="64008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F84D0B99-C322-E014-8A48-B594B6113BD6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4356"/>
          <a:stretch>
            <a:fillRect/>
          </a:stretch>
        </p:blipFill>
        <p:spPr>
          <a:xfrm>
            <a:off x="6374780" y="316825"/>
            <a:ext cx="6122020" cy="640080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EC9B90BE-695C-8B6A-85DC-8B04A17E0B9D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523" t="5105" r="95201"/>
          <a:stretch>
            <a:fillRect/>
          </a:stretch>
        </p:blipFill>
        <p:spPr>
          <a:xfrm>
            <a:off x="6041917" y="783943"/>
            <a:ext cx="273690" cy="607405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4EEB5BE-ACD4-42E8-3FC7-BF73FD2714A2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523" t="5105" r="95201"/>
          <a:stretch>
            <a:fillRect/>
          </a:stretch>
        </p:blipFill>
        <p:spPr>
          <a:xfrm>
            <a:off x="0" y="783943"/>
            <a:ext cx="273690" cy="6074057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60CD02B-E30A-BD4A-37B9-1142B6A75DFB}"/>
              </a:ext>
            </a:extLst>
          </p:cNvPr>
          <p:cNvSpPr txBox="1"/>
          <p:nvPr/>
        </p:nvSpPr>
        <p:spPr>
          <a:xfrm>
            <a:off x="9641582" y="-10882"/>
            <a:ext cx="258588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l Figure 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942782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ED18D7F-2EC0-8E01-7C92-68457D0171B6}"/>
              </a:ext>
            </a:extLst>
          </p:cNvPr>
          <p:cNvSpPr txBox="1"/>
          <p:nvPr/>
        </p:nvSpPr>
        <p:spPr>
          <a:xfrm>
            <a:off x="-3716" y="0"/>
            <a:ext cx="12195716" cy="25853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: </a:t>
            </a:r>
            <a:r>
              <a:rPr lang="en-US" sz="1800" b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ral Gargle HPV DNA Collected at Weekly Intervals from Weeks 1-4 and Their Associations with Reduction of Target Tumor Volume (TTV) at Week 4. </a:t>
            </a:r>
            <a:r>
              <a:rPr lang="en-US" sz="1800" b="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8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 Comparison of the reduction of TTV at week 4 in patients with versus without week 4 oral gargle </a:t>
            </a:r>
            <a:r>
              <a:rPr lang="en-US" sz="1800" kern="1200" dirty="0" err="1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fHPV</a:t>
            </a:r>
            <a:r>
              <a:rPr lang="en-US" sz="18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DNA clearance;</a:t>
            </a:r>
            <a:r>
              <a:rPr lang="en-US" sz="1800" b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800" b="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8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 week 1 oral gargle </a:t>
            </a:r>
            <a:r>
              <a:rPr lang="en-US" sz="1800" kern="1200" dirty="0" err="1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fHPV</a:t>
            </a:r>
            <a:r>
              <a:rPr lang="en-US" sz="18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DNA clearance; C) week 2 oral gargle </a:t>
            </a:r>
            <a:r>
              <a:rPr lang="en-US" sz="1800" kern="1200" dirty="0" err="1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fHPV</a:t>
            </a:r>
            <a:r>
              <a:rPr lang="en-US" sz="18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DNA clearance; and D) week 3 oral gargle </a:t>
            </a:r>
            <a:r>
              <a:rPr lang="en-US" sz="1800" kern="1200" dirty="0" err="1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efHPV</a:t>
            </a:r>
            <a:r>
              <a:rPr lang="en-US" sz="18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DNA clearance. Positive (i.e. &gt;0) numbers represent tumor volume reduction while negative (i.e. &lt;0) numbers represent tumor volume increase. Statistical test represents Mann-Whitney Test between the 2 groups overlaid by the bolded line. The median and upper and lower quartiles are represented in the bar graphs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01515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5</TotalTime>
  <Words>161</Words>
  <Application>Microsoft Macintosh PowerPoint</Application>
  <PresentationFormat>Widescreen</PresentationFormat>
  <Paragraphs>9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obin Park</dc:creator>
  <cp:lastModifiedBy>Robin Park</cp:lastModifiedBy>
  <cp:revision>18</cp:revision>
  <dcterms:created xsi:type="dcterms:W3CDTF">2025-06-06T20:18:21Z</dcterms:created>
  <dcterms:modified xsi:type="dcterms:W3CDTF">2025-07-09T00:33:08Z</dcterms:modified>
</cp:coreProperties>
</file>